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8999538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2"/>
    <p:restoredTop sz="94676"/>
  </p:normalViewPr>
  <p:slideViewPr>
    <p:cSldViewPr snapToGrid="0" snapToObjects="1">
      <p:cViewPr varScale="1">
        <p:scale>
          <a:sx n="139" d="100"/>
          <a:sy n="139" d="100"/>
        </p:scale>
        <p:origin x="122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ryo/Desktop/&#21069;&#24029;&#20808;&#29983;(&#22478;&#64017;)/ESC%20EP%20&#21050;&#28608;IGFBP1%20and%20PRL%20expression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ryo/Desktop/&#21069;&#24029;&#20808;&#29983;(&#22478;&#64017;)/ESC%20EP%20&#21050;&#28608;IGFBP1%20and%20PRL%20express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H$4:$H$5</c:f>
                <c:numCache>
                  <c:formatCode>General</c:formatCode>
                  <c:ptCount val="2"/>
                  <c:pt idx="0">
                    <c:v>1.8450122663625781E-6</c:v>
                  </c:pt>
                  <c:pt idx="1">
                    <c:v>5.7997779069523568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F$4:$F$5</c:f>
              <c:strCache>
                <c:ptCount val="2"/>
                <c:pt idx="0">
                  <c:v>control</c:v>
                </c:pt>
                <c:pt idx="1">
                  <c:v>E+MPA</c:v>
                </c:pt>
              </c:strCache>
            </c:strRef>
          </c:cat>
          <c:val>
            <c:numRef>
              <c:f>Sheet1!$G$4:$G$5</c:f>
              <c:numCache>
                <c:formatCode>General</c:formatCode>
                <c:ptCount val="2"/>
                <c:pt idx="0">
                  <c:v>1.5020804271023258E-5</c:v>
                </c:pt>
                <c:pt idx="1">
                  <c:v>6.03702974936661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C73-6C4D-905C-2C7E2849F8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6721024"/>
        <c:axId val="199334656"/>
      </c:barChart>
      <c:catAx>
        <c:axId val="867210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99334656"/>
        <c:crosses val="autoZero"/>
        <c:auto val="1"/>
        <c:lblAlgn val="ctr"/>
        <c:lblOffset val="100"/>
        <c:noMultiLvlLbl val="0"/>
      </c:catAx>
      <c:valAx>
        <c:axId val="19933465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8672102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H$13:$H$14</c:f>
                <c:numCache>
                  <c:formatCode>General</c:formatCode>
                  <c:ptCount val="2"/>
                  <c:pt idx="0">
                    <c:v>6.6396294379945021E-6</c:v>
                  </c:pt>
                  <c:pt idx="1">
                    <c:v>5.5406236420540586E-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F$13:$F$14</c:f>
              <c:strCache>
                <c:ptCount val="2"/>
                <c:pt idx="0">
                  <c:v>control</c:v>
                </c:pt>
                <c:pt idx="1">
                  <c:v>E+MPA</c:v>
                </c:pt>
              </c:strCache>
            </c:strRef>
          </c:cat>
          <c:val>
            <c:numRef>
              <c:f>Sheet1!$G$13:$G$14</c:f>
              <c:numCache>
                <c:formatCode>General</c:formatCode>
                <c:ptCount val="2"/>
                <c:pt idx="0">
                  <c:v>3.3298904353563619E-5</c:v>
                </c:pt>
                <c:pt idx="1">
                  <c:v>9.0788200278577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50-724E-B917-F13D48B71F1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9012224"/>
        <c:axId val="148934016"/>
      </c:barChart>
      <c:catAx>
        <c:axId val="490122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48934016"/>
        <c:crosses val="autoZero"/>
        <c:auto val="1"/>
        <c:lblAlgn val="ctr"/>
        <c:lblOffset val="100"/>
        <c:noMultiLvlLbl val="0"/>
      </c:catAx>
      <c:valAx>
        <c:axId val="14893401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4901222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122363"/>
            <a:ext cx="7649607" cy="2387600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3602038"/>
            <a:ext cx="6749654" cy="1655762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5775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5592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365125"/>
            <a:ext cx="194052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365125"/>
            <a:ext cx="5709082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33677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0100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1709740"/>
            <a:ext cx="7762102" cy="2852737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4589465"/>
            <a:ext cx="7762102" cy="1500187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04823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1825625"/>
            <a:ext cx="3824804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1825625"/>
            <a:ext cx="3824804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63007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365127"/>
            <a:ext cx="7762102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1681163"/>
            <a:ext cx="3807226" cy="823912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2505075"/>
            <a:ext cx="3807226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1681163"/>
            <a:ext cx="3825976" cy="823912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2505075"/>
            <a:ext cx="3825976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4876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822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3315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57200"/>
            <a:ext cx="2902585" cy="160020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987427"/>
            <a:ext cx="4556016" cy="4873625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057400"/>
            <a:ext cx="2902585" cy="3811588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88089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57200"/>
            <a:ext cx="2902585" cy="160020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987427"/>
            <a:ext cx="4556016" cy="4873625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057400"/>
            <a:ext cx="2902585" cy="3811588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3602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365127"/>
            <a:ext cx="776210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1825625"/>
            <a:ext cx="7762102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6356352"/>
            <a:ext cx="202489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92B309-9837-7843-8E20-6BF87E98F064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6356352"/>
            <a:ext cx="303734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6356352"/>
            <a:ext cx="202489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5513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kumimoji="1"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8661559"/>
              </p:ext>
            </p:extLst>
          </p:nvPr>
        </p:nvGraphicFramePr>
        <p:xfrm>
          <a:off x="652835" y="1979463"/>
          <a:ext cx="3511224" cy="21586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00000000-0008-0000-00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7080368"/>
              </p:ext>
            </p:extLst>
          </p:nvPr>
        </p:nvGraphicFramePr>
        <p:xfrm>
          <a:off x="4849003" y="1971304"/>
          <a:ext cx="3511224" cy="21668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7D46A9F-23ED-D04E-A4EF-443D8B9477DF}"/>
              </a:ext>
            </a:extLst>
          </p:cNvPr>
          <p:cNvSpPr txBox="1"/>
          <p:nvPr/>
        </p:nvSpPr>
        <p:spPr>
          <a:xfrm rot="16200000">
            <a:off x="244148" y="2753739"/>
            <a:ext cx="702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/GAPDH</a:t>
            </a:r>
            <a:endParaRPr kumimoji="1" lang="ja-JP" altLang="en-US" sz="120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05267E4-4670-4A44-AC2B-13632D7FD5C4}"/>
              </a:ext>
            </a:extLst>
          </p:cNvPr>
          <p:cNvSpPr txBox="1"/>
          <p:nvPr/>
        </p:nvSpPr>
        <p:spPr>
          <a:xfrm rot="16200000">
            <a:off x="4426041" y="2753740"/>
            <a:ext cx="702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/GAPDH</a:t>
            </a:r>
            <a:endParaRPr kumimoji="1" lang="ja-JP" altLang="en-US" sz="120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0B2EF90-5ED5-274A-812D-D996E914F1F4}"/>
              </a:ext>
            </a:extLst>
          </p:cNvPr>
          <p:cNvSpPr txBox="1"/>
          <p:nvPr/>
        </p:nvSpPr>
        <p:spPr>
          <a:xfrm>
            <a:off x="1949250" y="1413164"/>
            <a:ext cx="9368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IGFBP-1</a:t>
            </a:r>
            <a:endParaRPr kumimoji="1" lang="ja-JP" altLang="en-US" b="1" i="1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FBF5839-F68D-7D4D-943B-96A84A2DE697}"/>
              </a:ext>
            </a:extLst>
          </p:cNvPr>
          <p:cNvSpPr txBox="1"/>
          <p:nvPr/>
        </p:nvSpPr>
        <p:spPr>
          <a:xfrm>
            <a:off x="6240418" y="1413164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PRL</a:t>
            </a:r>
            <a:endParaRPr kumimoji="1" lang="ja-JP" altLang="en-US" b="1" i="1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0CD87FE-1C4C-4D43-B553-BB190DA0A4E1}"/>
              </a:ext>
            </a:extLst>
          </p:cNvPr>
          <p:cNvSpPr txBox="1"/>
          <p:nvPr/>
        </p:nvSpPr>
        <p:spPr>
          <a:xfrm>
            <a:off x="-7486" y="0"/>
            <a:ext cx="19561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Additional Figure 3</a:t>
            </a:r>
            <a:endParaRPr lang="ja-JP" altLang="en-US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E71E35A-0507-5245-8594-DEB331A80E55}"/>
              </a:ext>
            </a:extLst>
          </p:cNvPr>
          <p:cNvSpPr txBox="1"/>
          <p:nvPr/>
        </p:nvSpPr>
        <p:spPr>
          <a:xfrm>
            <a:off x="1191280" y="3861278"/>
            <a:ext cx="1287852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Non decidualized</a:t>
            </a:r>
          </a:p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ESC</a:t>
            </a:r>
            <a:endParaRPr kumimoji="1" lang="ja-JP" altLang="en-US" sz="12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2BC6EE1-0F5A-9C4D-B74D-8FB4552BCF69}"/>
              </a:ext>
            </a:extLst>
          </p:cNvPr>
          <p:cNvSpPr txBox="1"/>
          <p:nvPr/>
        </p:nvSpPr>
        <p:spPr>
          <a:xfrm>
            <a:off x="2794507" y="3861278"/>
            <a:ext cx="99931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Decidualized</a:t>
            </a:r>
          </a:p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ESC</a:t>
            </a:r>
            <a:endParaRPr kumimoji="1" lang="ja-JP" altLang="en-US" sz="12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C189B88-E5A5-5D42-A29C-68CB2F0C1B56}"/>
              </a:ext>
            </a:extLst>
          </p:cNvPr>
          <p:cNvSpPr txBox="1"/>
          <p:nvPr/>
        </p:nvSpPr>
        <p:spPr>
          <a:xfrm>
            <a:off x="5387232" y="3861278"/>
            <a:ext cx="1287852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Non decidualized</a:t>
            </a:r>
          </a:p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ESC</a:t>
            </a:r>
            <a:endParaRPr kumimoji="1" lang="ja-JP" altLang="en-US" sz="12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6639ACA-7817-FC4A-8620-24D7071636B3}"/>
              </a:ext>
            </a:extLst>
          </p:cNvPr>
          <p:cNvSpPr txBox="1"/>
          <p:nvPr/>
        </p:nvSpPr>
        <p:spPr>
          <a:xfrm>
            <a:off x="6990459" y="3861278"/>
            <a:ext cx="99931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Decidualized</a:t>
            </a:r>
          </a:p>
          <a:p>
            <a:pPr algn="ctr"/>
            <a:r>
              <a:rPr lang="en-US" altLang="ja-JP" sz="1200" b="1" dirty="0">
                <a:latin typeface="Calibri" panose="020F0502020204030204" pitchFamily="34" charset="0"/>
                <a:cs typeface="Calibri" panose="020F0502020204030204" pitchFamily="34" charset="0"/>
              </a:rPr>
              <a:t>ESC</a:t>
            </a:r>
            <a:endParaRPr kumimoji="1" lang="ja-JP" altLang="en-US" sz="12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94939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9</Words>
  <Application>Microsoft Macintosh PowerPoint</Application>
  <PresentationFormat>ユーザー設定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ryomaekawa@gmail.com</dc:creator>
  <cp:lastModifiedBy>ryomaekawa@gmail.com</cp:lastModifiedBy>
  <cp:revision>5</cp:revision>
  <dcterms:created xsi:type="dcterms:W3CDTF">2018-09-10T10:23:53Z</dcterms:created>
  <dcterms:modified xsi:type="dcterms:W3CDTF">2018-12-25T05:08:42Z</dcterms:modified>
</cp:coreProperties>
</file>